
<file path=[Content_Types].xml><?xml version="1.0" encoding="utf-8"?>
<Types xmlns="http://schemas.openxmlformats.org/package/2006/content-types"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60" r:id="rId5"/>
  </p:sldMasterIdLst>
  <p:notesMasterIdLst>
    <p:notesMasterId r:id="rId6"/>
  </p:notesMasterIdLst>
  <p:sldIdLst>
    <p:sldId id="256" r:id="rId7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E9F2A850-9AD8-4C83-9C8F-CDFADBCA08E1}">
  <a:tblStyle styleId="{E9F2A850-9AD8-4C83-9C8F-CDFADBCA08E1}" styleName="Table_0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394bd16cf8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8" name="Google Shape;58;g1394bd16cf8_0_0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re et contenu" type="obj">
  <p:cSld name="OBJECT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/>
          <p:nvPr>
            <p:ph type="title"/>
          </p:nvPr>
        </p:nvSpPr>
        <p:spPr>
          <a:xfrm>
            <a:off x="628650" y="273844"/>
            <a:ext cx="7886700" cy="9942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lv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52" name="Google Shape;52;p13"/>
          <p:cNvSpPr txBox="1"/>
          <p:nvPr>
            <p:ph idx="1" type="body"/>
          </p:nvPr>
        </p:nvSpPr>
        <p:spPr>
          <a:xfrm>
            <a:off x="628650" y="1369219"/>
            <a:ext cx="7886700" cy="32634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/>
          </a:bodyPr>
          <a:lstStyle>
            <a:lvl1pPr indent="-317500" lvl="0" marL="457200" rtl="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1pPr>
            <a:lvl2pPr indent="-317500" lvl="1" marL="914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2pPr>
            <a:lvl3pPr indent="-317500" lvl="2" marL="1371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3pPr>
            <a:lvl4pPr indent="-317500" lvl="3" marL="18288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4pPr>
            <a:lvl5pPr indent="-317500" lvl="4" marL="22860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5pPr>
            <a:lvl6pPr indent="-317500" lvl="5" marL="27432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6pPr>
            <a:lvl7pPr indent="-317500" lvl="6" marL="3200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7pPr>
            <a:lvl8pPr indent="-317500" lvl="7" marL="3657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8pPr>
            <a:lvl9pPr indent="-317500" lvl="8" marL="4114800" rtl="0" algn="l">
              <a:lnSpc>
                <a:spcPct val="90000"/>
              </a:lnSpc>
              <a:spcBef>
                <a:spcPts val="1200"/>
              </a:spcBef>
              <a:spcAft>
                <a:spcPts val="1200"/>
              </a:spcAft>
              <a:buClr>
                <a:schemeClr val="dk1"/>
              </a:buClr>
              <a:buSzPts val="1400"/>
              <a:buChar char="■"/>
              <a:defRPr/>
            </a:lvl9pPr>
          </a:lstStyle>
          <a:p/>
        </p:txBody>
      </p:sp>
      <p:sp>
        <p:nvSpPr>
          <p:cNvPr id="53" name="Google Shape;53;p13"/>
          <p:cNvSpPr txBox="1"/>
          <p:nvPr>
            <p:ph idx="10" type="dt"/>
          </p:nvPr>
        </p:nvSpPr>
        <p:spPr>
          <a:xfrm>
            <a:off x="6286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4" name="Google Shape;54;p13"/>
          <p:cNvSpPr txBox="1"/>
          <p:nvPr>
            <p:ph idx="11" type="ftr"/>
          </p:nvPr>
        </p:nvSpPr>
        <p:spPr>
          <a:xfrm>
            <a:off x="3028950" y="4767263"/>
            <a:ext cx="30861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5" name="Google Shape;55;p13"/>
          <p:cNvSpPr txBox="1"/>
          <p:nvPr>
            <p:ph idx="12" type="sldNum"/>
          </p:nvPr>
        </p:nvSpPr>
        <p:spPr>
          <a:xfrm>
            <a:off x="64579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indent="0" lvl="0" marL="0" rtl="0" algn="r">
              <a:spcBef>
                <a:spcPts val="0"/>
              </a:spcBef>
              <a:buNone/>
              <a:defRPr/>
            </a:lvl1pPr>
            <a:lvl2pPr indent="0" lvl="1" marL="0" rtl="0" algn="r">
              <a:spcBef>
                <a:spcPts val="0"/>
              </a:spcBef>
              <a:buNone/>
              <a:defRPr/>
            </a:lvl2pPr>
            <a:lvl3pPr indent="0" lvl="2" marL="0" rtl="0" algn="r">
              <a:spcBef>
                <a:spcPts val="0"/>
              </a:spcBef>
              <a:buNone/>
              <a:defRPr/>
            </a:lvl3pPr>
            <a:lvl4pPr indent="0" lvl="3" marL="0" rtl="0" algn="r">
              <a:spcBef>
                <a:spcPts val="0"/>
              </a:spcBef>
              <a:buNone/>
              <a:defRPr/>
            </a:lvl4pPr>
            <a:lvl5pPr indent="0" lvl="4" marL="0" rtl="0" algn="r">
              <a:spcBef>
                <a:spcPts val="0"/>
              </a:spcBef>
              <a:buNone/>
              <a:defRPr/>
            </a:lvl5pPr>
            <a:lvl6pPr indent="0" lvl="5" marL="0" rtl="0" algn="r">
              <a:spcBef>
                <a:spcPts val="0"/>
              </a:spcBef>
              <a:buNone/>
              <a:defRPr/>
            </a:lvl6pPr>
            <a:lvl7pPr indent="0" lvl="6" marL="0" rtl="0" algn="r">
              <a:spcBef>
                <a:spcPts val="0"/>
              </a:spcBef>
              <a:buNone/>
              <a:defRPr/>
            </a:lvl7pPr>
            <a:lvl8pPr indent="0" lvl="7" marL="0" rtl="0" algn="r">
              <a:spcBef>
                <a:spcPts val="0"/>
              </a:spcBef>
              <a:buNone/>
              <a:defRPr/>
            </a:lvl8pPr>
            <a:lvl9pPr indent="0" lvl="8" marL="0" rt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3" Type="http://schemas.openxmlformats.org/officeDocument/2006/relationships/theme" Target="../theme/theme1.xml"/><Relationship Id="rId12" Type="http://schemas.openxmlformats.org/officeDocument/2006/relationships/slideLayout" Target="../slideLayouts/slideLayout12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" name="Google Shape;60;p14"/>
          <p:cNvGraphicFramePr/>
          <p:nvPr/>
        </p:nvGraphicFramePr>
        <p:xfrm>
          <a:off x="195041" y="53817"/>
          <a:ext cx="3000000" cy="3000000"/>
        </p:xfrm>
        <a:graphic>
          <a:graphicData uri="http://schemas.openxmlformats.org/drawingml/2006/table">
            <a:tbl>
              <a:tblPr>
                <a:noFill/>
                <a:tableStyleId>{E9F2A850-9AD8-4C83-9C8F-CDFADBCA08E1}</a:tableStyleId>
              </a:tblPr>
              <a:tblGrid>
                <a:gridCol w="915675"/>
                <a:gridCol w="915675"/>
                <a:gridCol w="915675"/>
                <a:gridCol w="915675"/>
                <a:gridCol w="915675"/>
                <a:gridCol w="915675"/>
                <a:gridCol w="915675"/>
                <a:gridCol w="915675"/>
              </a:tblGrid>
              <a:tr h="2013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PD ID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ase Mean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Log2 Fold Change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djusted p-value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Phage order</a:t>
                      </a:r>
                      <a:endParaRPr b="1" sz="8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Phage family</a:t>
                      </a:r>
                      <a:endParaRPr b="1" sz="8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Phage species</a:t>
                      </a:r>
                      <a:endParaRPr b="1" sz="8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ost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3759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42467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9613.5951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441130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.595016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utyrivibrio virus Ara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Lachnospirales/Lachnospiraceae/Roseburia/Roseburia intestiUnknownli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857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0107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236.4041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354764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.639550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Listeria virus LP101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857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59802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6485.1787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5649116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9.431499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Listeria virus LP101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4484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0489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469.1798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370425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9.495116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ctinobacteriota/Actinobacteria/Actinomycetales/Bifidobacteriaceae/Bifidobacterium/Bifidobacterium adolescentis_B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3759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55715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257.7180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0.807577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004570e-02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Pod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acteroidota/Bacteroidia/Bacteroidales/Rikenellaceae/Tidjanibacter/Tidjanibacter massiliensi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857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19647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145.6632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409505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.218964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857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300370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956.249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5546601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.658079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583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42466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817.609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0.996986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117205e-0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y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eromoUnknowns phage PX29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857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38869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506.767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3466990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.847852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857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28028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204.7758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656375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.601215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4484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417922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058.235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227803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6.336420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ycobacterium virus Thibault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ctinobacteriota/Actinobacteria/Actinomycetales/Bifidobacteriaceae/Bifidobacterium/Bifidobacterium adolescentis_B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857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ivig_2237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973.816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0.6197120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826999e-02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583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1721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660.754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5839458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256007e-0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y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ecalibacterium virus Toutati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4484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55607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656.777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0.497846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.927361e-02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Lactobacillus virus phiAT3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ctinobacteriota/Actinobacteria/Actinomycetales/Bifidobacteriaceae/Bifidobacterium/Bifidobacterium adolescentis_B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583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30777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447.0972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5753198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9.898566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eobacillus phage GBK2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583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45250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279.0528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6103047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014497e-0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y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Edwardsiella virus MSW3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583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44792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039.4688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0.674670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373678e-02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y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ecalibacterium virus Mushu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3034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30437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977.9648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2.6873351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417751e-05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erelle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Lachnospirales/Lachnospiraceae/Lachnospira/Lachnospira eligens,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44847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89183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933.0571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831396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38108e-1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ordonia phage Schmidt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ctinobacteriota/Actinobacteria/Actinomycetales/Bifidobacteriaceae/Bifidobacterium/Bifidobacterium adolescentis_B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583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81278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873.9822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4517249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.840095e-04</a:t>
                      </a:r>
                      <a:endParaRPr sz="600" u="none" cap="none" strike="noStrike"/>
                    </a:p>
                  </a:txBody>
                  <a:tcPr marT="4825" marB="4825" marR="4825" marL="482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yoviridae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ecalibacterium virus Mushu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8350" marB="8350" marR="12500" marL="125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1" name="Google Shape;61;p14"/>
          <p:cNvSpPr txBox="1"/>
          <p:nvPr/>
        </p:nvSpPr>
        <p:spPr>
          <a:xfrm>
            <a:off x="7515375" y="2158450"/>
            <a:ext cx="1646700" cy="9069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 fontScale="92500" lnSpcReduction="20000"/>
          </a:bodyPr>
          <a:lstStyle/>
          <a:p>
            <a:pPr indent="-172085" lvl="0" marL="17780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100000"/>
              <a:buFont typeface="Arial"/>
              <a:buChar char="•"/>
            </a:pPr>
            <a:r>
              <a:rPr lang="fr" sz="1200">
                <a:solidFill>
                  <a:srgbClr val="000000"/>
                </a:solidFill>
                <a:latin typeface="Trebuchet MS"/>
                <a:ea typeface="Trebuchet MS"/>
                <a:cs typeface="Trebuchet MS"/>
                <a:sym typeface="Trebuchet MS"/>
              </a:rPr>
              <a:t>20 significantly </a:t>
            </a:r>
            <a:r>
              <a:rPr lang="fr" sz="1200">
                <a:latin typeface="Trebuchet MS"/>
                <a:ea typeface="Trebuchet MS"/>
                <a:cs typeface="Trebuchet MS"/>
                <a:sym typeface="Trebuchet MS"/>
              </a:rPr>
              <a:t>d</a:t>
            </a:r>
            <a:r>
              <a:rPr lang="fr" sz="1200">
                <a:solidFill>
                  <a:srgbClr val="000000"/>
                </a:solidFill>
                <a:latin typeface="Trebuchet MS"/>
                <a:ea typeface="Trebuchet MS"/>
                <a:cs typeface="Trebuchet MS"/>
                <a:sym typeface="Trebuchet MS"/>
              </a:rPr>
              <a:t>ifferentially abundant phages with the highest </a:t>
            </a:r>
            <a:r>
              <a:rPr lang="fr" sz="1200">
                <a:latin typeface="Trebuchet MS"/>
                <a:ea typeface="Trebuchet MS"/>
                <a:cs typeface="Trebuchet MS"/>
                <a:sym typeface="Trebuchet MS"/>
              </a:rPr>
              <a:t>base mean</a:t>
            </a:r>
            <a:r>
              <a:rPr lang="fr" sz="1200">
                <a:latin typeface="Trebuchet MS"/>
                <a:ea typeface="Trebuchet MS"/>
                <a:cs typeface="Trebuchet MS"/>
                <a:sym typeface="Trebuchet MS"/>
              </a:rPr>
              <a:t> obtained using the GPD approach</a:t>
            </a:r>
            <a:r>
              <a:rPr lang="fr" sz="1200">
                <a:solidFill>
                  <a:srgbClr val="000000"/>
                </a:solidFill>
                <a:latin typeface="Trebuchet MS"/>
                <a:ea typeface="Trebuchet MS"/>
                <a:cs typeface="Trebuchet MS"/>
                <a:sym typeface="Trebuchet MS"/>
              </a:rPr>
              <a:t>. </a:t>
            </a:r>
            <a:endParaRPr sz="800">
              <a:solidFill>
                <a:srgbClr val="000000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